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63"/>
  </p:normalViewPr>
  <p:slideViewPr>
    <p:cSldViewPr snapToGrid="0" snapToObjects="1">
      <p:cViewPr varScale="1">
        <p:scale>
          <a:sx n="105" d="100"/>
          <a:sy n="105" d="100"/>
        </p:scale>
        <p:origin x="7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p Ming Raymond Tang" userId="b2aa4765-ef8e-4cd1-b324-f15d0c86e60f" providerId="ADAL" clId="{B930ABEF-4CB9-41D8-925C-099D770CAAFC}"/>
    <pc:docChg chg="modSld">
      <pc:chgData name="Lap Ming Raymond Tang" userId="b2aa4765-ef8e-4cd1-b324-f15d0c86e60f" providerId="ADAL" clId="{B930ABEF-4CB9-41D8-925C-099D770CAAFC}" dt="2021-08-18T09:12:30.718" v="9" actId="20577"/>
      <pc:docMkLst>
        <pc:docMk/>
      </pc:docMkLst>
      <pc:sldChg chg="addSp modSp">
        <pc:chgData name="Lap Ming Raymond Tang" userId="b2aa4765-ef8e-4cd1-b324-f15d0c86e60f" providerId="ADAL" clId="{B930ABEF-4CB9-41D8-925C-099D770CAAFC}" dt="2021-08-18T09:12:30.718" v="9" actId="20577"/>
        <pc:sldMkLst>
          <pc:docMk/>
          <pc:sldMk cId="177668792" sldId="256"/>
        </pc:sldMkLst>
        <pc:spChg chg="add mod">
          <ac:chgData name="Lap Ming Raymond Tang" userId="b2aa4765-ef8e-4cd1-b324-f15d0c86e60f" providerId="ADAL" clId="{B930ABEF-4CB9-41D8-925C-099D770CAAFC}" dt="2021-08-18T09:12:30.718" v="9" actId="20577"/>
          <ac:spMkLst>
            <pc:docMk/>
            <pc:sldMk cId="177668792" sldId="256"/>
            <ac:spMk id="2" creationId="{6A0C44A4-554C-4334-B2B1-47AF7E1A68DD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8DB77-BED3-314D-99F9-F3B9D3AD37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94B1397-7CEC-0B48-964C-204BA965F6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92C3E6-E9AB-5748-BFB8-145501037F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BAEBAB-86FC-ED47-B5BC-480113B6A5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635A16-D22E-CE44-8832-F92541056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951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10B0F1-553A-954F-8FC9-5992AA29C0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858595-B7CF-434D-ABD9-33C55DF2E3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F0A491-9010-C344-828D-0815189CB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CFAF56-D9ED-6641-B7D4-B73991F37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D4CDE1-BC0F-1D45-A4CB-1CE03C20C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085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8CA2B8-BBE0-8142-B3B9-F38C1DEC539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89BAC1-BE73-484B-8ECB-3FF4EAB321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E436D5-81E7-3F47-A5DC-CFB679D1C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4D8F3B-A497-A84A-AC9E-E67A84451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E0A4FC-F17E-AF4D-B591-C7830D671C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806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43B36D-AEC7-6546-AE26-7572A926AF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BF8B07-3AEF-2045-82FE-85A807EE58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2FF061-C618-B54D-9BD7-D7F66C8FB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BFBEF2-88F3-C348-9712-63DB53798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A29A81-B56F-294A-A098-4FE89D92E7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889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859B7-3A1B-0A4E-A7CD-97C5EE7144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8E5F0E-42DA-654A-A3C0-4AF6898C82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6F9B2E-583D-C641-AB5D-F2896115B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8FA676-6943-1547-B255-CDE250D93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55795A-A0FD-0744-913F-48357245C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276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B10182-46A9-7D48-9E77-8677C3F17B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9ABDE6-74E0-7644-B94A-D00213D2594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BFC514-D4F9-2C48-B30F-FA8EC2A7D4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4E4F77-D20B-6E4E-B5D0-B7A858089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6958FA-D8F9-9349-9DA0-D32321908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98A4A6-3DEC-884B-8FC5-4FC19C787C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434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A339F5-3211-9740-B074-A71D903387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B88A24-DA39-E645-94E0-F6AB0356EC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1412C21-93C5-8E40-BDFC-418DBB73A7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5932632-4CA5-AB4D-AB7E-EC1A6B29E8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5CBF2E7-6AF0-154F-9834-52E92D465E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44762C-BBB8-6C4D-AA18-926A0B40C4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5B3BEC8-3156-654C-ABCB-1AD05DBC6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F3EA441-D131-F64C-8384-F04DEB8B7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4506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2907A6-846B-1E43-8E1F-E1255BD395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2A5ACA-D8E1-0D4C-B8CF-5712DF297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C22A60E-A8C6-8D42-97E3-7FC1A39D8B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788690-47EC-6647-BE6B-7DCD1D67A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7295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FD5933-F88F-874E-8214-159E55DAEB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89F5EC5-3B9D-B24B-8569-2BA293F51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F79C13-AD3B-6D48-9933-414CA2F34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8089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4D0072-B23C-F649-B761-44D66B257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F1000D-773C-1249-9D10-AA0F9771F2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97A186-A9FF-A14F-A1DF-DDE40DE25D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D9E650-014A-ED4A-BD73-4A1B260E0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3FC06D-6A3C-0143-AE39-2F33AA0CD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44EC93-ACD8-A24C-A56C-A207786F0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9268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5CCBA4-5787-4E4D-9600-77ADAE9D34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47A47D6-BECF-FD4C-A8EF-B05E8C0C60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3383A59-EC5C-F746-A428-7E0A1CFAC9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7181FF-5B21-EB4E-8EA0-38E356590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D7762C-C113-D143-859E-FD38C63E2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C9C904-57BC-DC47-BEDE-A550A4856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56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ACFF27-5A89-1B45-B0D6-7A1638839B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4D9E7B-4A48-244A-9C2D-55DF7BEE9D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2CE92F-84B4-8142-8DD2-7FCE41D5B0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43A23-752C-B543-BC75-2F8B75B0F922}" type="datetimeFigureOut">
              <a:rPr lang="en-US" smtClean="0"/>
              <a:t>8/18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9DE1F3-FEAF-E14E-8154-D6C975F8BA2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7763C-58FD-4A4D-AFE2-9468E11CE8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F6A7E8-FB40-A440-A10B-95F3DEADED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0350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>
            <a:extLst>
              <a:ext uri="{FF2B5EF4-FFF2-40B4-BE49-F238E27FC236}">
                <a16:creationId xmlns:a16="http://schemas.microsoft.com/office/drawing/2014/main" id="{9E83177C-A457-D14A-A819-5DBC9D385582}"/>
              </a:ext>
            </a:extLst>
          </p:cNvPr>
          <p:cNvGrpSpPr/>
          <p:nvPr/>
        </p:nvGrpSpPr>
        <p:grpSpPr>
          <a:xfrm>
            <a:off x="1399494" y="1270737"/>
            <a:ext cx="8537240" cy="2916351"/>
            <a:chOff x="1728107" y="979714"/>
            <a:chExt cx="8537240" cy="2916351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646720A-365B-9B40-A181-FB792D2C9301}"/>
                </a:ext>
              </a:extLst>
            </p:cNvPr>
            <p:cNvSpPr txBox="1"/>
            <p:nvPr/>
          </p:nvSpPr>
          <p:spPr>
            <a:xfrm>
              <a:off x="8082537" y="1503984"/>
              <a:ext cx="19460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ousehold Income</a:t>
              </a:r>
            </a:p>
          </p:txBody>
        </p:sp>
        <p:sp>
          <p:nvSpPr>
            <p:cNvPr id="8" name="Oval 7">
              <a:extLst>
                <a:ext uri="{FF2B5EF4-FFF2-40B4-BE49-F238E27FC236}">
                  <a16:creationId xmlns:a16="http://schemas.microsoft.com/office/drawing/2014/main" id="{EEA67D7A-6A7E-6F40-A237-876539BD9EC0}"/>
                </a:ext>
              </a:extLst>
            </p:cNvPr>
            <p:cNvSpPr/>
            <p:nvPr/>
          </p:nvSpPr>
          <p:spPr>
            <a:xfrm>
              <a:off x="1728107" y="979714"/>
              <a:ext cx="2362675" cy="1282474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3CEAEC4-3156-5B44-9FA9-A8730D774828}"/>
                </a:ext>
              </a:extLst>
            </p:cNvPr>
            <p:cNvSpPr txBox="1"/>
            <p:nvPr/>
          </p:nvSpPr>
          <p:spPr>
            <a:xfrm>
              <a:off x="1989252" y="1432544"/>
              <a:ext cx="17640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elf-rated Health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F1CB3A2A-DDC9-5A4D-92B1-34D1B99E25BB}"/>
                </a:ext>
              </a:extLst>
            </p:cNvPr>
            <p:cNvSpPr/>
            <p:nvPr/>
          </p:nvSpPr>
          <p:spPr>
            <a:xfrm>
              <a:off x="5005830" y="3070162"/>
              <a:ext cx="218034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/>
                <a:t>Satisfaction with Life</a:t>
              </a:r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9E939F99-F684-1B4F-8DCB-3076F561DC45}"/>
                </a:ext>
              </a:extLst>
            </p:cNvPr>
            <p:cNvSpPr/>
            <p:nvPr/>
          </p:nvSpPr>
          <p:spPr>
            <a:xfrm>
              <a:off x="7902672" y="1051154"/>
              <a:ext cx="2362675" cy="1282474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0DC42C4C-9674-3A41-9A23-3D07A5B1E495}"/>
                </a:ext>
              </a:extLst>
            </p:cNvPr>
            <p:cNvSpPr/>
            <p:nvPr/>
          </p:nvSpPr>
          <p:spPr>
            <a:xfrm>
              <a:off x="4823495" y="2613591"/>
              <a:ext cx="2362675" cy="1282474"/>
            </a:xfrm>
            <a:prstGeom prst="ellipse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Down Arrow 18">
              <a:extLst>
                <a:ext uri="{FF2B5EF4-FFF2-40B4-BE49-F238E27FC236}">
                  <a16:creationId xmlns:a16="http://schemas.microsoft.com/office/drawing/2014/main" id="{164B07E4-70C1-1941-8B48-D886C5939269}"/>
                </a:ext>
              </a:extLst>
            </p:cNvPr>
            <p:cNvSpPr/>
            <p:nvPr/>
          </p:nvSpPr>
          <p:spPr>
            <a:xfrm rot="18296840">
              <a:off x="4244489" y="1805068"/>
              <a:ext cx="423313" cy="1318494"/>
            </a:xfrm>
            <a:prstGeom prst="downArrow">
              <a:avLst/>
            </a:prstGeom>
            <a:solidFill>
              <a:schemeClr val="tx1">
                <a:lumMod val="50000"/>
                <a:lumOff val="50000"/>
              </a:schemeClr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1" name="Down Arrow 20">
              <a:extLst>
                <a:ext uri="{FF2B5EF4-FFF2-40B4-BE49-F238E27FC236}">
                  <a16:creationId xmlns:a16="http://schemas.microsoft.com/office/drawing/2014/main" id="{AFF8B3D8-BBCB-C149-AEFF-E96D0684A33A}"/>
                </a:ext>
              </a:extLst>
            </p:cNvPr>
            <p:cNvSpPr/>
            <p:nvPr/>
          </p:nvSpPr>
          <p:spPr>
            <a:xfrm rot="3083864">
              <a:off x="7279030" y="1847148"/>
              <a:ext cx="423313" cy="1224522"/>
            </a:xfrm>
            <a:prstGeom prst="downArrow">
              <a:avLst/>
            </a:prstGeom>
            <a:solidFill>
              <a:schemeClr val="tx1">
                <a:lumMod val="50000"/>
                <a:lumOff val="50000"/>
              </a:schemeClr>
            </a:solidFill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86569A4-4A31-A742-953C-FC0E00CFA5C7}"/>
                </a:ext>
              </a:extLst>
            </p:cNvPr>
            <p:cNvSpPr txBox="1"/>
            <p:nvPr/>
          </p:nvSpPr>
          <p:spPr>
            <a:xfrm>
              <a:off x="4366238" y="202618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1316202-7CFF-A549-BB4C-CAD908239AF6}"/>
                </a:ext>
              </a:extLst>
            </p:cNvPr>
            <p:cNvSpPr txBox="1"/>
            <p:nvPr/>
          </p:nvSpPr>
          <p:spPr>
            <a:xfrm>
              <a:off x="7155608" y="2054759"/>
              <a:ext cx="4498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1F1F2C5-1453-3C49-90FB-3BE22EC7E5B0}"/>
                  </a:ext>
                </a:extLst>
              </p:cNvPr>
              <p:cNvSpPr txBox="1"/>
              <p:nvPr/>
            </p:nvSpPr>
            <p:spPr>
              <a:xfrm>
                <a:off x="1607958" y="4304790"/>
                <a:ext cx="8612074" cy="858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14:m>
                  <m:oMath xmlns:m="http://schemas.openxmlformats.org/officeDocument/2006/math">
                    <m:f>
                      <m:fPr>
                        <m:ctrlPr>
                          <a:rPr lang="en-HK" sz="2400" i="1">
                            <a:latin typeface="Cambria Math" panose="02040503050406030204" pitchFamily="18" charset="0"/>
                          </a:rPr>
                        </m:ctrlPr>
                      </m:fPr>
                      <m:num>
                        <m:r>
                          <a:rPr lang="en-HK" sz="2400" i="1">
                            <a:latin typeface="Cambria Math" panose="02040503050406030204" pitchFamily="18" charset="0"/>
                          </a:rPr>
                          <m:t>𝑎</m:t>
                        </m:r>
                      </m:num>
                      <m:den>
                        <m:r>
                          <a:rPr lang="en-HK" sz="2400" i="1">
                            <a:latin typeface="Cambria Math" panose="02040503050406030204" pitchFamily="18" charset="0"/>
                          </a:rPr>
                          <m:t>𝑏</m:t>
                        </m:r>
                      </m:den>
                    </m:f>
                  </m:oMath>
                </a14:m>
                <a:r>
                  <a:rPr lang="en-HK" i="1" dirty="0"/>
                  <a:t> </a:t>
                </a:r>
                <a:r>
                  <a:rPr lang="en-HK" dirty="0"/>
                  <a:t>: “</a:t>
                </a:r>
                <a:r>
                  <a:rPr lang="en-US" dirty="0"/>
                  <a:t>implicit willingness-to-pay” (</a:t>
                </a:r>
                <a:r>
                  <a:rPr lang="en-AU" dirty="0"/>
                  <a:t>marginal rate of substitution</a:t>
                </a:r>
                <a:r>
                  <a:rPr lang="en-US" dirty="0"/>
                  <a:t>) of </a:t>
                </a:r>
                <a:r>
                  <a:rPr lang="en-AU" dirty="0"/>
                  <a:t>self-rated health with respect to individual’s household income</a:t>
                </a:r>
                <a:endParaRPr lang="en-HK" dirty="0"/>
              </a:p>
            </p:txBody>
          </p:sp>
        </mc:Choice>
        <mc:Fallback xmlns=""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1F1F2C5-1453-3C49-90FB-3BE22EC7E5B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607958" y="4304790"/>
                <a:ext cx="8612074" cy="858055"/>
              </a:xfrm>
              <a:prstGeom prst="rect">
                <a:avLst/>
              </a:prstGeom>
              <a:blipFill>
                <a:blip r:embed="rId2"/>
                <a:stretch>
                  <a:fillRect l="-589" b="-10145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" name="Rectangle 1">
            <a:extLst>
              <a:ext uri="{FF2B5EF4-FFF2-40B4-BE49-F238E27FC236}">
                <a16:creationId xmlns:a16="http://schemas.microsoft.com/office/drawing/2014/main" id="{6A0C44A4-554C-4334-B2B1-47AF7E1A68DD}"/>
              </a:ext>
            </a:extLst>
          </p:cNvPr>
          <p:cNvSpPr/>
          <p:nvPr/>
        </p:nvSpPr>
        <p:spPr>
          <a:xfrm>
            <a:off x="360539" y="421768"/>
            <a:ext cx="11106912" cy="4617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GB" sz="1400" b="1" dirty="0">
                <a:latin typeface="Times New Roman" panose="02020603050405020304" pitchFamily="18" charset="0"/>
                <a:ea typeface="PMingLiU" panose="02020500000000000000" pitchFamily="18" charset="-120"/>
                <a:cs typeface="Arial" panose="020B0604020202020204" pitchFamily="34" charset="0"/>
              </a:rPr>
              <a:t>Additional file 1:</a:t>
            </a:r>
            <a:r>
              <a:rPr lang="en-GB" sz="1400" dirty="0">
                <a:latin typeface="Times New Roman" panose="02020603050405020304" pitchFamily="18" charset="0"/>
                <a:ea typeface="PMingLiU" panose="02020500000000000000" pitchFamily="18" charset="-120"/>
                <a:cs typeface="Arial" panose="020B0604020202020204" pitchFamily="34" charset="0"/>
              </a:rPr>
              <a:t> A conceptual illustration of the implicit willingness-to-pay of self-rated health with respect to an individual’s household income</a:t>
            </a:r>
            <a:endParaRPr lang="en-GB" sz="1400" dirty="0">
              <a:latin typeface="Calibri" panose="020F0502020204030204" pitchFamily="34" charset="0"/>
              <a:ea typeface="PMingLiU" panose="02020500000000000000" pitchFamily="18" charset="-12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76687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51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PMingLiU</vt:lpstr>
      <vt:lpstr>Arial</vt:lpstr>
      <vt:lpstr>Calibri</vt:lpstr>
      <vt:lpstr>Calibri Light</vt:lpstr>
      <vt:lpstr>Cambria Math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 Chan</dc:creator>
  <cp:lastModifiedBy>Raymond LM. Tang</cp:lastModifiedBy>
  <cp:revision>1</cp:revision>
  <dcterms:created xsi:type="dcterms:W3CDTF">2021-08-16T05:02:35Z</dcterms:created>
  <dcterms:modified xsi:type="dcterms:W3CDTF">2021-08-18T09:12:36Z</dcterms:modified>
</cp:coreProperties>
</file>